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67" r:id="rId2"/>
    <p:sldId id="260" r:id="rId3"/>
    <p:sldId id="266" r:id="rId4"/>
    <p:sldId id="264" r:id="rId5"/>
    <p:sldId id="265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58"/>
  </p:normalViewPr>
  <p:slideViewPr>
    <p:cSldViewPr snapToGrid="0">
      <p:cViewPr varScale="1">
        <p:scale>
          <a:sx n="120" d="100"/>
          <a:sy n="120" d="100"/>
        </p:scale>
        <p:origin x="8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Xuling Chang" userId="119bcda2-c8fb-4353-851b-58d2ee082112" providerId="ADAL" clId="{9B5AAC74-90AD-52D4-8119-B83A328B23DB}"/>
    <pc:docChg chg="undo custSel modSld">
      <pc:chgData name="Xuling Chang" userId="119bcda2-c8fb-4353-851b-58d2ee082112" providerId="ADAL" clId="{9B5AAC74-90AD-52D4-8119-B83A328B23DB}" dt="2026-05-09T02:18:56.772" v="229" actId="20577"/>
      <pc:docMkLst>
        <pc:docMk/>
      </pc:docMkLst>
      <pc:sldChg chg="modSp mod">
        <pc:chgData name="Xuling Chang" userId="119bcda2-c8fb-4353-851b-58d2ee082112" providerId="ADAL" clId="{9B5AAC74-90AD-52D4-8119-B83A328B23DB}" dt="2026-05-09T02:18:46.610" v="223" actId="20577"/>
        <pc:sldMkLst>
          <pc:docMk/>
          <pc:sldMk cId="3847332793" sldId="260"/>
        </pc:sldMkLst>
        <pc:spChg chg="mod">
          <ac:chgData name="Xuling Chang" userId="119bcda2-c8fb-4353-851b-58d2ee082112" providerId="ADAL" clId="{9B5AAC74-90AD-52D4-8119-B83A328B23DB}" dt="2026-05-09T02:18:46.610" v="223" actId="20577"/>
          <ac:spMkLst>
            <pc:docMk/>
            <pc:sldMk cId="3847332793" sldId="260"/>
            <ac:spMk id="4" creationId="{5B5F7517-350F-0407-CBB6-34086BED3754}"/>
          </ac:spMkLst>
        </pc:spChg>
      </pc:sldChg>
      <pc:sldChg chg="modSp mod">
        <pc:chgData name="Xuling Chang" userId="119bcda2-c8fb-4353-851b-58d2ee082112" providerId="ADAL" clId="{9B5AAC74-90AD-52D4-8119-B83A328B23DB}" dt="2026-05-09T02:18:52.715" v="227" actId="20577"/>
        <pc:sldMkLst>
          <pc:docMk/>
          <pc:sldMk cId="1288760415" sldId="264"/>
        </pc:sldMkLst>
        <pc:spChg chg="mod">
          <ac:chgData name="Xuling Chang" userId="119bcda2-c8fb-4353-851b-58d2ee082112" providerId="ADAL" clId="{9B5AAC74-90AD-52D4-8119-B83A328B23DB}" dt="2026-05-09T02:18:52.715" v="227" actId="20577"/>
          <ac:spMkLst>
            <pc:docMk/>
            <pc:sldMk cId="1288760415" sldId="264"/>
            <ac:spMk id="4" creationId="{0334A353-7019-8E59-7211-C84292492FA0}"/>
          </ac:spMkLst>
        </pc:spChg>
      </pc:sldChg>
      <pc:sldChg chg="modSp mod">
        <pc:chgData name="Xuling Chang" userId="119bcda2-c8fb-4353-851b-58d2ee082112" providerId="ADAL" clId="{9B5AAC74-90AD-52D4-8119-B83A328B23DB}" dt="2026-05-09T02:18:56.772" v="229" actId="20577"/>
        <pc:sldMkLst>
          <pc:docMk/>
          <pc:sldMk cId="2895816268" sldId="265"/>
        </pc:sldMkLst>
        <pc:spChg chg="mod">
          <ac:chgData name="Xuling Chang" userId="119bcda2-c8fb-4353-851b-58d2ee082112" providerId="ADAL" clId="{9B5AAC74-90AD-52D4-8119-B83A328B23DB}" dt="2026-05-09T02:18:56.772" v="229" actId="20577"/>
          <ac:spMkLst>
            <pc:docMk/>
            <pc:sldMk cId="2895816268" sldId="265"/>
            <ac:spMk id="5" creationId="{0334A353-7019-8E59-7211-C84292492FA0}"/>
          </ac:spMkLst>
        </pc:spChg>
      </pc:sldChg>
      <pc:sldChg chg="modSp mod">
        <pc:chgData name="Xuling Chang" userId="119bcda2-c8fb-4353-851b-58d2ee082112" providerId="ADAL" clId="{9B5AAC74-90AD-52D4-8119-B83A328B23DB}" dt="2026-05-09T02:18:49.745" v="225" actId="20577"/>
        <pc:sldMkLst>
          <pc:docMk/>
          <pc:sldMk cId="4288541803" sldId="266"/>
        </pc:sldMkLst>
        <pc:spChg chg="mod">
          <ac:chgData name="Xuling Chang" userId="119bcda2-c8fb-4353-851b-58d2ee082112" providerId="ADAL" clId="{9B5AAC74-90AD-52D4-8119-B83A328B23DB}" dt="2026-05-09T02:18:49.745" v="225" actId="20577"/>
          <ac:spMkLst>
            <pc:docMk/>
            <pc:sldMk cId="4288541803" sldId="266"/>
            <ac:spMk id="6" creationId="{BC247B80-4A66-EAE5-1C73-F5FADBEDC413}"/>
          </ac:spMkLst>
        </pc:spChg>
      </pc:sldChg>
      <pc:sldChg chg="modSp mod">
        <pc:chgData name="Xuling Chang" userId="119bcda2-c8fb-4353-851b-58d2ee082112" providerId="ADAL" clId="{9B5AAC74-90AD-52D4-8119-B83A328B23DB}" dt="2026-05-09T02:18:41.265" v="221" actId="20577"/>
        <pc:sldMkLst>
          <pc:docMk/>
          <pc:sldMk cId="3023853041" sldId="267"/>
        </pc:sldMkLst>
        <pc:spChg chg="mod">
          <ac:chgData name="Xuling Chang" userId="119bcda2-c8fb-4353-851b-58d2ee082112" providerId="ADAL" clId="{9B5AAC74-90AD-52D4-8119-B83A328B23DB}" dt="2026-05-09T02:18:41.265" v="221" actId="20577"/>
          <ac:spMkLst>
            <pc:docMk/>
            <pc:sldMk cId="3023853041" sldId="267"/>
            <ac:spMk id="6" creationId="{5B5F7517-350F-0407-CBB6-34086BED3754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AE643A-619B-FE42-84A5-851BC55922F9}" type="datetimeFigureOut">
              <a:rPr lang="en-US" smtClean="0"/>
              <a:t>5/9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4D161D-AED1-6840-83CF-AA68D6910C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8058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E4D161D-AED1-6840-83CF-AA68D6910C3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44410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E4D161D-AED1-6840-83CF-AA68D6910C3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05939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A1F824-D8EC-4B1A-0B0F-35AD455F8B4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4B05923-46BF-C101-0AF1-4F05C57C7ED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04E8DE-70D4-B986-786E-C9E9455DE8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2B59-36F5-3948-82C1-A200001D1004}" type="datetimeFigureOut">
              <a:rPr lang="en-US" smtClean="0"/>
              <a:t>5/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D3D7B4-BD45-485A-7D36-9B87751537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2FFDF3-B4FB-FAF0-BA34-DD1F71F4AD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6DDA0-CC16-F348-89BA-39B594942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4230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01EE2B-5848-F356-3299-98775C328F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0860D28-3665-3AE9-299C-B7A4493069F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A5B82B-D3FA-360D-FC8A-97F9CD92B9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2B59-36F5-3948-82C1-A200001D1004}" type="datetimeFigureOut">
              <a:rPr lang="en-US" smtClean="0"/>
              <a:t>5/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E954D3-DF24-EA7B-9029-BEA69ADF02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2EECED-95EE-9A60-6295-EA7001951A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6DDA0-CC16-F348-89BA-39B594942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2224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E10C4A6-5F46-E939-8FBA-19288DF3BD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D92AA01-1332-DE98-56A4-8E0D0714EC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3EBCEC-CE5B-F40E-7409-B6280D14FF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2B59-36F5-3948-82C1-A200001D1004}" type="datetimeFigureOut">
              <a:rPr lang="en-US" smtClean="0"/>
              <a:t>5/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33EBE6-91F3-2E45-C37F-C48F2E144A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EF6F1B-46BC-05CF-5C27-8E08A1F2FC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6DDA0-CC16-F348-89BA-39B594942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0126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4CCE58-98BA-9207-5244-C94D91C4AA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F7C11E-AC25-FC26-42FB-A3B7F929EE7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FF57A0-B932-3641-8AFE-5E05A71C96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2B59-36F5-3948-82C1-A200001D1004}" type="datetimeFigureOut">
              <a:rPr lang="en-US" smtClean="0"/>
              <a:t>5/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1DC9A6-72D4-C6DA-264B-5F195B225A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169A82-FB52-4CAC-6D0B-A73B92F8BE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6DDA0-CC16-F348-89BA-39B594942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4051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4474A9-7CFC-F75A-7AEF-B5AEE564DC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27048D-C280-A0F3-C7BD-1C4A4676BE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F96B6A-DA2E-B5C4-ECD9-5B801FEECC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2B59-36F5-3948-82C1-A200001D1004}" type="datetimeFigureOut">
              <a:rPr lang="en-US" smtClean="0"/>
              <a:t>5/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05ABB4-E4BD-BE3E-AB66-00F4B38EBD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F7A270-22B0-5618-81BB-6C9D37A585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6DDA0-CC16-F348-89BA-39B594942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85317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05B9D2-B8F0-83E9-82FB-A977BCD67F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27261E-0FA4-EF0C-E3DC-5D04524377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0FF9C83-7779-9261-BB3F-77AA6F6C6A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37F9FE-4F05-059D-C02B-D636B77247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2B59-36F5-3948-82C1-A200001D1004}" type="datetimeFigureOut">
              <a:rPr lang="en-US" smtClean="0"/>
              <a:t>5/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F3C7CBD-B282-C1B6-5AFC-37D13D98D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9975E4-4F8C-35AB-3FF2-2221B2E03F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6DDA0-CC16-F348-89BA-39B594942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7124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5EE344-27EC-4607-8012-CD3C537BCF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DE68F3-541A-DC3A-7AB6-F18DA71635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B62883-6C4F-A077-978B-8BA58C521B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B693232-6142-3467-E61C-B016844B96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8D9EE92-20EB-364D-6023-1404ADDC63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DFE2500-18F8-642C-F763-C1E61CC5AF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2B59-36F5-3948-82C1-A200001D1004}" type="datetimeFigureOut">
              <a:rPr lang="en-US" smtClean="0"/>
              <a:t>5/9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796A4CE-0AAB-B785-AE44-4F2ECE6E9E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4F99F10-0635-44E2-B628-3BFC4CF32A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6DDA0-CC16-F348-89BA-39B594942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96418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B3B464-36CC-557F-524A-7961E9FC8A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4DDBF39-24C6-974D-230B-CC4D0A50A1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2B59-36F5-3948-82C1-A200001D1004}" type="datetimeFigureOut">
              <a:rPr lang="en-US" smtClean="0"/>
              <a:t>5/9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ABCA4FE-6375-9037-9642-68BF22F37A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D1A1A55-140A-00EC-6502-BF68B0918E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6DDA0-CC16-F348-89BA-39B594942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364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FE19CF2-92CE-5CDF-9DF9-26AF03312A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2B59-36F5-3948-82C1-A200001D1004}" type="datetimeFigureOut">
              <a:rPr lang="en-US" smtClean="0"/>
              <a:t>5/9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AE04A3D-55B6-3E71-65BE-5374A96B49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1FA7414-BD5B-BC6C-010C-3B3516886C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6DDA0-CC16-F348-89BA-39B594942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46933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854B58-3344-84C9-C895-91A78F7D66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BE6E1B2-3664-BE30-2C0C-F5606213C8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C7F156B-5CF6-0266-45CB-08C60E532C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A1F86F-CAC5-A982-091E-FAEFC4EEA4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2B59-36F5-3948-82C1-A200001D1004}" type="datetimeFigureOut">
              <a:rPr lang="en-US" smtClean="0"/>
              <a:t>5/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88BAA8-1872-67EE-B167-2C99ADB4FB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00F222-864C-5766-1FF4-F97D9E8C5E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6DDA0-CC16-F348-89BA-39B594942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3107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176F61-3905-A0E4-A6E3-575FDF60D9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263D71A-E0A8-71ED-A18C-0BE9A8418BC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4EBB776-3DA7-1A26-F2AD-56C2376276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7D2F69-F46C-BC0C-51BC-909B74D398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92B59-36F5-3948-82C1-A200001D1004}" type="datetimeFigureOut">
              <a:rPr lang="en-US" smtClean="0"/>
              <a:t>5/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05D858-F5AB-01B5-BD41-5689670158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E59689-C995-612A-F43D-53C82FDE74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46DDA0-CC16-F348-89BA-39B594942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6788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94205BE-6431-D236-948A-6D2D815918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D14999-7E44-8FAF-39D9-7AB48FE7B5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F58FC9-847C-7539-16A5-AFB81B8F8D4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192B59-36F5-3948-82C1-A200001D1004}" type="datetimeFigureOut">
              <a:rPr lang="en-US" smtClean="0"/>
              <a:t>5/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03A894-2A52-32A2-54E7-C4E08BE6750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E6E963-CA8C-5818-745E-454B99BD89C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46DDA0-CC16-F348-89BA-39B594942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7541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3">
            <a:extLst>
              <a:ext uri="{FF2B5EF4-FFF2-40B4-BE49-F238E27FC236}">
                <a16:creationId xmlns:a16="http://schemas.microsoft.com/office/drawing/2014/main" id="{5B5F7517-350F-0407-CBB6-34086BED3754}"/>
              </a:ext>
            </a:extLst>
          </p:cNvPr>
          <p:cNvSpPr txBox="1"/>
          <p:nvPr/>
        </p:nvSpPr>
        <p:spPr>
          <a:xfrm>
            <a:off x="0" y="0"/>
            <a:ext cx="121158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: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A plots for the SCHS and Vietnamese datasets. </a:t>
            </a:r>
            <a:r>
              <a:rPr lang="en-AU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C1 vs PC2 for SCHS samples genotyped on the GSA; </a:t>
            </a:r>
            <a:r>
              <a:rPr lang="en-AU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C1 vs PC3 for SCHS samples genotyped on the GSA; </a:t>
            </a:r>
            <a:r>
              <a:rPr lang="en-AU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C1 vs PC2 for SCHS samples genotyped on the Zhonghua chip; </a:t>
            </a:r>
            <a:r>
              <a:rPr lang="en-AU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C1 vs PC3 for SCHS samples genotyped on the Zhonghua chip; </a:t>
            </a:r>
            <a:r>
              <a:rPr lang="en-AU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</a:t>
            </a:r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C1 vs PC2 for samples in the Vietnamese dataset; </a:t>
            </a:r>
            <a:r>
              <a:rPr lang="en-AU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. </a:t>
            </a:r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1 vs PC3 for samples in the Vietnamese dataset.</a:t>
            </a:r>
            <a:endParaRPr 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767227E5-BCAC-A04D-938D-F9DEC1A7742A}"/>
              </a:ext>
            </a:extLst>
          </p:cNvPr>
          <p:cNvGrpSpPr/>
          <p:nvPr/>
        </p:nvGrpSpPr>
        <p:grpSpPr>
          <a:xfrm>
            <a:off x="-4414" y="1186935"/>
            <a:ext cx="8707648" cy="5678038"/>
            <a:chOff x="-4414" y="1186935"/>
            <a:chExt cx="8707648" cy="5678038"/>
          </a:xfrm>
        </p:grpSpPr>
        <p:pic>
          <p:nvPicPr>
            <p:cNvPr id="8" name="Picture 7" descr="A diagram of a diagram with yellow dots&#10;&#10;AI-generated content may be incorrect.">
              <a:extLst>
                <a:ext uri="{FF2B5EF4-FFF2-40B4-BE49-F238E27FC236}">
                  <a16:creationId xmlns:a16="http://schemas.microsoft.com/office/drawing/2014/main" id="{A5640427-CE95-CA26-1C9A-45DEF820AC2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1186935"/>
              <a:ext cx="2899607" cy="2839019"/>
            </a:xfrm>
            <a:prstGeom prst="rect">
              <a:avLst/>
            </a:prstGeom>
          </p:spPr>
        </p:pic>
        <p:pic>
          <p:nvPicPr>
            <p:cNvPr id="14" name="Picture 13" descr="A diagram of a number of yellow dots&#10;&#10;AI-generated content may be incorrect.">
              <a:extLst>
                <a:ext uri="{FF2B5EF4-FFF2-40B4-BE49-F238E27FC236}">
                  <a16:creationId xmlns:a16="http://schemas.microsoft.com/office/drawing/2014/main" id="{DB68F9AE-3DD3-E1AB-549E-120E17DA3F9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899607" y="1186935"/>
              <a:ext cx="2899607" cy="2839019"/>
            </a:xfrm>
            <a:prstGeom prst="rect">
              <a:avLst/>
            </a:prstGeom>
          </p:spPr>
        </p:pic>
        <p:pic>
          <p:nvPicPr>
            <p:cNvPr id="16" name="Picture 15" descr="A diagram of a number of yellow dots&#10;&#10;AI-generated content may be incorrect.">
              <a:extLst>
                <a:ext uri="{FF2B5EF4-FFF2-40B4-BE49-F238E27FC236}">
                  <a16:creationId xmlns:a16="http://schemas.microsoft.com/office/drawing/2014/main" id="{70A92D9F-F3A1-A572-513F-C381124CBD6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799214" y="1186936"/>
              <a:ext cx="2895194" cy="2839018"/>
            </a:xfrm>
            <a:prstGeom prst="rect">
              <a:avLst/>
            </a:prstGeom>
          </p:spPr>
        </p:pic>
        <p:pic>
          <p:nvPicPr>
            <p:cNvPr id="18" name="Picture 17" descr="A diagram of a number of red and yellow dots&#10;&#10;AI-generated content may be incorrect.">
              <a:extLst>
                <a:ext uri="{FF2B5EF4-FFF2-40B4-BE49-F238E27FC236}">
                  <a16:creationId xmlns:a16="http://schemas.microsoft.com/office/drawing/2014/main" id="{02E8921C-C1E0-A781-93CF-72DE51CA732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413" y="4018982"/>
              <a:ext cx="2895194" cy="2839018"/>
            </a:xfrm>
            <a:prstGeom prst="rect">
              <a:avLst/>
            </a:prstGeom>
          </p:spPr>
        </p:pic>
        <p:pic>
          <p:nvPicPr>
            <p:cNvPr id="20" name="Picture 19" descr="A diagram of a number of red and yellow dots&#10;&#10;AI-generated content may be incorrect.">
              <a:extLst>
                <a:ext uri="{FF2B5EF4-FFF2-40B4-BE49-F238E27FC236}">
                  <a16:creationId xmlns:a16="http://schemas.microsoft.com/office/drawing/2014/main" id="{2CC4A1B0-C5DC-4E2B-E3D8-26DC19559ED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895193" y="4025954"/>
              <a:ext cx="2899608" cy="2839019"/>
            </a:xfrm>
            <a:prstGeom prst="rect">
              <a:avLst/>
            </a:prstGeom>
          </p:spPr>
        </p:pic>
        <p:pic>
          <p:nvPicPr>
            <p:cNvPr id="22" name="Picture 21" descr="A diagram of red and yellow dots&#10;&#10;AI-generated content may be incorrect.">
              <a:extLst>
                <a:ext uri="{FF2B5EF4-FFF2-40B4-BE49-F238E27FC236}">
                  <a16:creationId xmlns:a16="http://schemas.microsoft.com/office/drawing/2014/main" id="{3268AC65-D296-A22A-D50D-053E4D58B01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803627" y="4018981"/>
              <a:ext cx="2899607" cy="2839019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E0A2CCBF-F72E-F755-F0A2-7DC3699968AB}"/>
                </a:ext>
              </a:extLst>
            </p:cNvPr>
            <p:cNvSpPr txBox="1"/>
            <p:nvPr/>
          </p:nvSpPr>
          <p:spPr>
            <a:xfrm>
              <a:off x="0" y="1186935"/>
              <a:ext cx="406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.</a:t>
              </a:r>
            </a:p>
          </p:txBody>
        </p:sp>
        <p:sp>
          <p:nvSpPr>
            <p:cNvPr id="24" name="TextBox 8">
              <a:extLst>
                <a:ext uri="{FF2B5EF4-FFF2-40B4-BE49-F238E27FC236}">
                  <a16:creationId xmlns:a16="http://schemas.microsoft.com/office/drawing/2014/main" id="{33696138-C610-B74F-99B0-9B192F79A4B1}"/>
                </a:ext>
              </a:extLst>
            </p:cNvPr>
            <p:cNvSpPr txBox="1"/>
            <p:nvPr/>
          </p:nvSpPr>
          <p:spPr>
            <a:xfrm>
              <a:off x="2899607" y="1186935"/>
              <a:ext cx="406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.</a:t>
              </a:r>
            </a:p>
          </p:txBody>
        </p:sp>
        <p:sp>
          <p:nvSpPr>
            <p:cNvPr id="25" name="TextBox 8">
              <a:extLst>
                <a:ext uri="{FF2B5EF4-FFF2-40B4-BE49-F238E27FC236}">
                  <a16:creationId xmlns:a16="http://schemas.microsoft.com/office/drawing/2014/main" id="{33696138-C610-B74F-99B0-9B192F79A4B1}"/>
                </a:ext>
              </a:extLst>
            </p:cNvPr>
            <p:cNvSpPr txBox="1"/>
            <p:nvPr/>
          </p:nvSpPr>
          <p:spPr>
            <a:xfrm>
              <a:off x="5790388" y="1186935"/>
              <a:ext cx="406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.</a:t>
              </a:r>
            </a:p>
          </p:txBody>
        </p:sp>
        <p:sp>
          <p:nvSpPr>
            <p:cNvPr id="26" name="TextBox 8">
              <a:extLst>
                <a:ext uri="{FF2B5EF4-FFF2-40B4-BE49-F238E27FC236}">
                  <a16:creationId xmlns:a16="http://schemas.microsoft.com/office/drawing/2014/main" id="{33696138-C610-B74F-99B0-9B192F79A4B1}"/>
                </a:ext>
              </a:extLst>
            </p:cNvPr>
            <p:cNvSpPr txBox="1"/>
            <p:nvPr/>
          </p:nvSpPr>
          <p:spPr>
            <a:xfrm>
              <a:off x="-4414" y="4074115"/>
              <a:ext cx="406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.</a:t>
              </a:r>
            </a:p>
          </p:txBody>
        </p:sp>
        <p:sp>
          <p:nvSpPr>
            <p:cNvPr id="27" name="TextBox 8">
              <a:extLst>
                <a:ext uri="{FF2B5EF4-FFF2-40B4-BE49-F238E27FC236}">
                  <a16:creationId xmlns:a16="http://schemas.microsoft.com/office/drawing/2014/main" id="{33696138-C610-B74F-99B0-9B192F79A4B1}"/>
                </a:ext>
              </a:extLst>
            </p:cNvPr>
            <p:cNvSpPr txBox="1"/>
            <p:nvPr/>
          </p:nvSpPr>
          <p:spPr>
            <a:xfrm>
              <a:off x="2904020" y="4074114"/>
              <a:ext cx="406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e.</a:t>
              </a:r>
            </a:p>
          </p:txBody>
        </p:sp>
        <p:sp>
          <p:nvSpPr>
            <p:cNvPr id="28" name="TextBox 8">
              <a:extLst>
                <a:ext uri="{FF2B5EF4-FFF2-40B4-BE49-F238E27FC236}">
                  <a16:creationId xmlns:a16="http://schemas.microsoft.com/office/drawing/2014/main" id="{33696138-C610-B74F-99B0-9B192F79A4B1}"/>
                </a:ext>
              </a:extLst>
            </p:cNvPr>
            <p:cNvSpPr txBox="1"/>
            <p:nvPr/>
          </p:nvSpPr>
          <p:spPr>
            <a:xfrm>
              <a:off x="5790387" y="4074113"/>
              <a:ext cx="406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238530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B5F7517-350F-0407-CBB6-34086BED3754}"/>
              </a:ext>
            </a:extLst>
          </p:cNvPr>
          <p:cNvSpPr txBox="1"/>
          <p:nvPr/>
        </p:nvSpPr>
        <p:spPr>
          <a:xfrm>
            <a:off x="-1" y="-5777"/>
            <a:ext cx="12291237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: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TB GWAS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ing logistic regression</a:t>
            </a:r>
            <a:r>
              <a:rPr lang="en-AU" sz="16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 </a:t>
            </a:r>
            <a:r>
              <a:rPr lang="en-AU" sz="1600" b="1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AU" sz="16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 Manhattan plot of the GWAS analysis</a:t>
            </a:r>
            <a:r>
              <a:rPr lang="zh-CN" altLang="en-US" sz="16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n the Singapore Chinese Health Study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CHS, 1,610 cases/24,015 controls)</a:t>
            </a:r>
            <a:r>
              <a:rPr lang="en-AU" sz="16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 </a:t>
            </a:r>
            <a:r>
              <a:rPr lang="en-AU" sz="1600" b="1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AU" sz="16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 QQ-plot of observed compared to expected </a:t>
            </a:r>
            <a:r>
              <a:rPr lang="en-AU" sz="1600" b="0" i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AU" sz="16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values indicated minimal inflation (</a:t>
            </a:r>
            <a:r>
              <a:rPr lang="el-GR" sz="1600" b="0" i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λ</a:t>
            </a:r>
            <a:r>
              <a:rPr lang="el-GR" sz="16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 = 1.0</a:t>
            </a:r>
            <a:r>
              <a:rPr lang="en-AU" sz="16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7</a:t>
            </a:r>
            <a:r>
              <a:rPr lang="el-GR" sz="16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AU" sz="16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in SCHS.</a:t>
            </a:r>
            <a:r>
              <a:rPr lang="en-AU" sz="1600" b="0" i="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AU" sz="1600" b="1" dirty="0">
                <a:solidFill>
                  <a:srgbClr val="22222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AU" sz="1600" b="0" i="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 Manhattan plot of the GWAS analysis in Vietnam (1,598 cases/1,267 controls). </a:t>
            </a:r>
            <a:r>
              <a:rPr lang="en-AU" sz="1600" b="1" i="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AU" sz="1600" b="0" i="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 QQ-plot of observed compared to expected </a:t>
            </a:r>
            <a:r>
              <a:rPr lang="en-AU" sz="1600" b="0" i="1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AU" sz="1600" b="0" i="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values indicated minimal inflation (</a:t>
            </a:r>
            <a:r>
              <a:rPr lang="el-GR" sz="1600" b="0" i="1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λ</a:t>
            </a:r>
            <a:r>
              <a:rPr lang="el-GR" sz="1600" b="0" i="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 = </a:t>
            </a:r>
            <a:r>
              <a:rPr lang="en-AU" sz="1600" dirty="0">
                <a:solidFill>
                  <a:srgbClr val="22222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0.985</a:t>
            </a:r>
            <a:r>
              <a:rPr lang="el-GR" sz="1600" b="0" i="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AU" sz="1600" b="0" i="0" dirty="0">
                <a:solidFill>
                  <a:srgbClr val="222222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in Vietnam</a:t>
            </a:r>
            <a:r>
              <a:rPr lang="en-AU" sz="1600" dirty="0">
                <a:solidFill>
                  <a:srgbClr val="22222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A391CC50-0F8B-509D-2035-A93DA4F6F5DE}"/>
              </a:ext>
            </a:extLst>
          </p:cNvPr>
          <p:cNvGrpSpPr/>
          <p:nvPr/>
        </p:nvGrpSpPr>
        <p:grpSpPr>
          <a:xfrm>
            <a:off x="98270" y="2093490"/>
            <a:ext cx="6151419" cy="3503930"/>
            <a:chOff x="22070" y="1062132"/>
            <a:chExt cx="6151419" cy="3503930"/>
          </a:xfrm>
        </p:grpSpPr>
        <p:pic>
          <p:nvPicPr>
            <p:cNvPr id="6" name="Picture 5" descr="A graph showing a number of different colored bars&#10;&#10;Description automatically generated with medium confidence">
              <a:extLst>
                <a:ext uri="{FF2B5EF4-FFF2-40B4-BE49-F238E27FC236}">
                  <a16:creationId xmlns:a16="http://schemas.microsoft.com/office/drawing/2014/main" id="{E9CEB3CD-C2DE-BF2A-63F3-C4C81B211D7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2070" y="1734215"/>
              <a:ext cx="6151419" cy="2831847"/>
            </a:xfrm>
            <a:prstGeom prst="rect">
              <a:avLst/>
            </a:prstGeom>
          </p:spPr>
        </p:pic>
        <p:pic>
          <p:nvPicPr>
            <p:cNvPr id="8" name="Picture 7" descr="A graph of a graph&#10;&#10;Description automatically generated">
              <a:extLst>
                <a:ext uri="{FF2B5EF4-FFF2-40B4-BE49-F238E27FC236}">
                  <a16:creationId xmlns:a16="http://schemas.microsoft.com/office/drawing/2014/main" id="{EACF0AA6-518B-A2F8-835A-828C019755A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417158" y="1062133"/>
              <a:ext cx="1327379" cy="1222135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3696138-C610-B74F-99B0-9B192F79A4B1}"/>
                </a:ext>
              </a:extLst>
            </p:cNvPr>
            <p:cNvSpPr txBox="1"/>
            <p:nvPr/>
          </p:nvSpPr>
          <p:spPr>
            <a:xfrm>
              <a:off x="151025" y="1651453"/>
              <a:ext cx="4065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.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330F99C-EBBE-D41E-55BA-4D1CC537D92F}"/>
                </a:ext>
              </a:extLst>
            </p:cNvPr>
            <p:cNvSpPr txBox="1"/>
            <p:nvPr/>
          </p:nvSpPr>
          <p:spPr>
            <a:xfrm>
              <a:off x="4242587" y="1062132"/>
              <a:ext cx="34914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b.</a:t>
              </a:r>
            </a:p>
          </p:txBody>
        </p: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id="{11D4E70A-AB99-D59B-72BF-593767FEEE14}"/>
              </a:ext>
            </a:extLst>
          </p:cNvPr>
          <p:cNvGrpSpPr/>
          <p:nvPr/>
        </p:nvGrpSpPr>
        <p:grpSpPr>
          <a:xfrm>
            <a:off x="6117338" y="2103710"/>
            <a:ext cx="6074662" cy="3494355"/>
            <a:chOff x="6041138" y="1072352"/>
            <a:chExt cx="6074662" cy="3494355"/>
          </a:xfrm>
        </p:grpSpPr>
        <p:pic>
          <p:nvPicPr>
            <p:cNvPr id="14" name="Picture 13" descr="A graph of a number of black and grey bars&#10;&#10;AI-generated content may be incorrect.">
              <a:extLst>
                <a:ext uri="{FF2B5EF4-FFF2-40B4-BE49-F238E27FC236}">
                  <a16:creationId xmlns:a16="http://schemas.microsoft.com/office/drawing/2014/main" id="{7BFBABF7-31B8-E3E5-C45E-A51F7C6ED6A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041138" y="1734215"/>
              <a:ext cx="5664984" cy="2832492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0682AA1-C55C-6AC7-6385-0B6927EED112}"/>
                </a:ext>
              </a:extLst>
            </p:cNvPr>
            <p:cNvSpPr txBox="1"/>
            <p:nvPr/>
          </p:nvSpPr>
          <p:spPr>
            <a:xfrm>
              <a:off x="6058788" y="1614937"/>
              <a:ext cx="424130" cy="3116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.</a:t>
              </a:r>
            </a:p>
          </p:txBody>
        </p:sp>
        <p:pic>
          <p:nvPicPr>
            <p:cNvPr id="18" name="Picture 17" descr="A graph of a graph&#10;&#10;AI-generated content may be incorrect.">
              <a:extLst>
                <a:ext uri="{FF2B5EF4-FFF2-40B4-BE49-F238E27FC236}">
                  <a16:creationId xmlns:a16="http://schemas.microsoft.com/office/drawing/2014/main" id="{E1F9D462-B376-EA06-B295-D4F3AF75485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0792074" y="1072352"/>
              <a:ext cx="1323726" cy="1323726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1C9FE6E-5593-8429-6FB2-C1D140897655}"/>
                </a:ext>
              </a:extLst>
            </p:cNvPr>
            <p:cNvSpPr txBox="1"/>
            <p:nvPr/>
          </p:nvSpPr>
          <p:spPr>
            <a:xfrm>
              <a:off x="10614807" y="1092304"/>
              <a:ext cx="337489" cy="315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8473327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C247B80-4A66-EAE5-1C73-F5FADBEDC413}"/>
              </a:ext>
            </a:extLst>
          </p:cNvPr>
          <p:cNvSpPr txBox="1"/>
          <p:nvPr/>
        </p:nvSpPr>
        <p:spPr>
          <a:xfrm>
            <a:off x="0" y="0"/>
            <a:ext cx="1226997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: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est plot showing the association of rs6006426 with PTB across individual datasets (SCHS, Vietnamese, Han Chinese, Biobank Japan and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KB+FinnGen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alyzed using logistic regression and the combined meta-analysis for East Asian </a:t>
            </a:r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meta-analysis EAS)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all datasets (</a:t>
            </a:r>
            <a:r>
              <a:rPr lang="en-AU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-analysis EAS+EUR)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formed using fixed-effect inverse-variance weighting. Meta-analysis results are highlighted in bold.</a:t>
            </a:r>
            <a:endParaRPr 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 descr="A graph of a person and person&#10;&#10;AI-generated content may be incorrect.">
            <a:extLst>
              <a:ext uri="{FF2B5EF4-FFF2-40B4-BE49-F238E27FC236}">
                <a16:creationId xmlns:a16="http://schemas.microsoft.com/office/drawing/2014/main" id="{06190F99-0D85-C35D-F342-318BB1F97A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9842" y="909767"/>
            <a:ext cx="12092315" cy="50384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85418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334A353-7019-8E59-7211-C84292492FA0}"/>
              </a:ext>
            </a:extLst>
          </p:cNvPr>
          <p:cNvSpPr txBox="1"/>
          <p:nvPr/>
        </p:nvSpPr>
        <p:spPr>
          <a:xfrm>
            <a:off x="0" y="0"/>
            <a:ext cx="120630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: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gnificant differential expression of candidate genes within ±400kb of rs6006426 in monocytes from Singaporean pulmonary tuberculosis patients (comprising Chinese, Malay, and Indian ethnicities).</a:t>
            </a:r>
            <a:endParaRPr 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837C2EAF-F7F9-9478-4FE4-09288D5CF20B}"/>
              </a:ext>
            </a:extLst>
          </p:cNvPr>
          <p:cNvGrpSpPr/>
          <p:nvPr/>
        </p:nvGrpSpPr>
        <p:grpSpPr>
          <a:xfrm>
            <a:off x="217855" y="929218"/>
            <a:ext cx="5484446" cy="5729965"/>
            <a:chOff x="92706" y="1335618"/>
            <a:chExt cx="5756845" cy="6401367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6756C74A-49E1-F25F-AEFA-10A8A603282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2706" y="4678778"/>
              <a:ext cx="2621320" cy="3058207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E9F912E4-E594-732D-07D1-7843D26046C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2706" y="1335618"/>
              <a:ext cx="2621321" cy="3047285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AD63F7DD-8FC8-9F00-84FE-578E656E24D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228230" y="1335618"/>
              <a:ext cx="2621321" cy="3047285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B117B72C-B9EF-1CB9-6332-C65063B26A5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192273" y="4678778"/>
              <a:ext cx="2610398" cy="304728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2887604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3">
            <a:extLst>
              <a:ext uri="{FF2B5EF4-FFF2-40B4-BE49-F238E27FC236}">
                <a16:creationId xmlns:a16="http://schemas.microsoft.com/office/drawing/2014/main" id="{0334A353-7019-8E59-7211-C84292492FA0}"/>
              </a:ext>
            </a:extLst>
          </p:cNvPr>
          <p:cNvSpPr txBox="1"/>
          <p:nvPr/>
        </p:nvSpPr>
        <p:spPr>
          <a:xfrm>
            <a:off x="0" y="0"/>
            <a:ext cx="120630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: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unctional analysis of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f3a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zebrafish-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rinum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ection model.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rinum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fection burden in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f3a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nockdown zebrafish embryos;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mbryo morphology in 2 day post 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ertilisation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f3a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nockdown;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</a:t>
            </a:r>
            <a:r>
              <a:rPr lang="en-US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rinum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fection burden in low-dose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f3a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nockdown zebrafish embryos.</a:t>
            </a:r>
            <a:endParaRPr lang="en-US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Picture 6" descr="A close-up of several images of a sperm&#10;&#10;Description automatically generated">
            <a:extLst>
              <a:ext uri="{FF2B5EF4-FFF2-40B4-BE49-F238E27FC236}">
                <a16:creationId xmlns:a16="http://schemas.microsoft.com/office/drawing/2014/main" id="{588BCEF2-9FBB-9BC1-8F72-6FA5387371E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96546"/>
            <a:ext cx="9903594" cy="40649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58162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</TotalTime>
  <Words>350</Words>
  <Application>Microsoft Macintosh PowerPoint</Application>
  <PresentationFormat>Widescreen</PresentationFormat>
  <Paragraphs>17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ptos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rley Chang</dc:creator>
  <cp:lastModifiedBy>Xuling Chang</cp:lastModifiedBy>
  <cp:revision>1</cp:revision>
  <dcterms:created xsi:type="dcterms:W3CDTF">2023-11-20T05:33:37Z</dcterms:created>
  <dcterms:modified xsi:type="dcterms:W3CDTF">2026-05-09T02:19:01Z</dcterms:modified>
</cp:coreProperties>
</file>